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2C8C3-E73C-414A-B8B5-BF757B433A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43D3ACB-2911-4B5B-9696-5D29277C3A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CFAB24-061B-4F32-A838-150404ED5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E690E4-3FD9-4C9E-B8ED-D252DF4C5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D744DE-A62F-4E40-B1BD-5DE436A6D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561679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D65DF0-7B54-442C-8B74-2E14EF8CB3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34FF15-2989-48B7-A691-F27A377F84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C1F972-D161-43B2-A098-126CD5503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7FED68-0C4C-4E5C-84FD-2E1D21430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5E64C2-06F1-4EE4-A45C-C22DCCE41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565180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5A767D-4973-4058-800A-C45A4F9295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8C8102-1011-4A62-9F86-928B4AB130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22F667-BCC8-45FC-A649-A63AD613C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72CA0-57E1-4657-A9AE-3A48127B3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46B318-7719-4C97-BF7E-CB97C51E7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521198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9410F7-160E-4591-B5B9-39FADD6958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9021DA-B003-4623-9912-656ED04673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A727EB-9053-4251-929C-50B800FCA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9098CE-00DB-42C2-8824-4B2D18FE9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9645F2-4B7F-45C7-96C0-F9800B1B5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816552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2C962-8A13-48CC-9A5D-0A8D4497D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0AC914-ED3B-4C4D-BF0E-8C83BE05BA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CF868C-A725-4232-91FE-52A542244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D31965-6EB2-4544-B90A-440074CD4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E1FD2C-7E38-49A1-A1B8-4767C973F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167273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DC5C3B-C6BF-4FC1-9EB7-B21232C353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7722A5-47A4-43DE-B248-00376662E7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2C95DF-639D-4DE3-B213-2EF075A0CE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8A09F8-6D73-439F-B09E-09034BF50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3CDC03-A8FA-4FD1-AFDB-2A6478F82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FC630F-F993-4454-B2E0-86CCE8CBA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287474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1E951-89B8-4E2B-9151-7676C4C355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E1D65B-8D58-478F-9AC2-BB6B099FA0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EF7FEF-D24C-41E8-87CB-CE1A5E1BD3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059B380-8557-4D3D-99C8-D812714563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B1D41F0-8B98-4AD0-9C8D-50381E2C04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BFF01B-14D8-4760-BDBA-6A48356BA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8482ACE-3FBC-47F4-AB03-D64041190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621F21B-25EA-4133-BE8F-3A9ECD3B9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28128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93941-F12A-4189-8989-BAE492AEEB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3752E5-7DC5-47F8-904F-69C3ACC39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086FAA-9EA4-4394-8DEA-1E32535F3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832359-19BC-4ABB-9E6C-57108179F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506982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42B5BE-9475-4EDA-878E-FF8A696EC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FEBE234-A596-4E96-8615-93551F9CC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DCD86A-B452-4F7D-B7F3-820D3C07D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870586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D6E20-524A-40F2-8768-4672A1DEF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9CC9F4-4AEC-4191-AA82-03025C76F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F624E7-2DEC-46C7-8AAC-0B568F6B0F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6B5020-329A-4BC7-B65C-C4D7939B8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9EBB52-50C9-4108-A5C0-EC2F514492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6101AC-7EC2-400E-8504-491E76185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798479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4D6A1B-D629-4501-93B2-8EF90545BD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BF708F-4733-4163-BE85-E14F61009E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788959-4806-4340-B14E-BE34193E09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1D8B7A-CD40-4DA6-B011-5CB7335DE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A0FF6C-3FEF-47BB-A096-F19EBFFB1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4A37D2-E7AA-4367-9560-78ADB7C5F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089757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D1392CD-63D5-4F96-BF01-0527FC56F5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A130BA-DCE1-41EA-AEF3-75751DC927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400D5F-F034-4477-B609-40211801CE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3C6B0-E322-4292-96FD-E8E5D94B1287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1ED856-652A-4116-A7FF-943E7D9E13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A74C33-1C4D-48C1-B062-99ADB3EABF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0C45E1-6000-4059-BC97-ADBC4EA041B2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72984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FA8AEB6-5816-41A3-BA60-E059AD8E63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8859" y="717616"/>
            <a:ext cx="7726260" cy="522788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F213D3E-508D-4F70-76D0-BF93EDE8650D}"/>
              </a:ext>
            </a:extLst>
          </p:cNvPr>
          <p:cNvSpPr txBox="1"/>
          <p:nvPr/>
        </p:nvSpPr>
        <p:spPr>
          <a:xfrm>
            <a:off x="3691156" y="1677798"/>
            <a:ext cx="56877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6a. Reference range of WBC, RBC, HGB, HCT, MCV, MCH, MCHC for healthy babies aged 3 months</a:t>
            </a:r>
          </a:p>
        </p:txBody>
      </p:sp>
    </p:spTree>
    <p:extLst>
      <p:ext uri="{BB962C8B-B14F-4D97-AF65-F5344CB8AC3E}">
        <p14:creationId xmlns:p14="http://schemas.microsoft.com/office/powerpoint/2010/main" val="2263683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744D844-CC8A-4CD4-93BC-16F108F8FD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4577" y="941003"/>
            <a:ext cx="8946374" cy="505712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1EAC79F-A7F2-EF8D-3BE1-AAC266FC325D}"/>
              </a:ext>
            </a:extLst>
          </p:cNvPr>
          <p:cNvSpPr txBox="1"/>
          <p:nvPr/>
        </p:nvSpPr>
        <p:spPr>
          <a:xfrm>
            <a:off x="3556932" y="1946246"/>
            <a:ext cx="65014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6b. Reference range of PLT, RDW SD, RDW CV, PDW, MPV, PCT, for healthy babies aged 3 months</a:t>
            </a:r>
          </a:p>
        </p:txBody>
      </p:sp>
    </p:spTree>
    <p:extLst>
      <p:ext uri="{BB962C8B-B14F-4D97-AF65-F5344CB8AC3E}">
        <p14:creationId xmlns:p14="http://schemas.microsoft.com/office/powerpoint/2010/main" val="17755122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5F9C08A-31DE-474C-BF93-BE1DFE0EDC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9206" y="746620"/>
            <a:ext cx="9731146" cy="527667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338DF87-B4D9-7F0A-A17D-BE8EC8D88375}"/>
              </a:ext>
            </a:extLst>
          </p:cNvPr>
          <p:cNvSpPr txBox="1"/>
          <p:nvPr/>
        </p:nvSpPr>
        <p:spPr>
          <a:xfrm>
            <a:off x="2650921" y="1988191"/>
            <a:ext cx="79947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6c. Reference range of neutrophil, lymphocyte, monocyte, eosinophil, eosinophil </a:t>
            </a:r>
            <a:r>
              <a:rPr lang="en-ID" dirty="0" err="1"/>
              <a:t>absolut</a:t>
            </a:r>
            <a:r>
              <a:rPr lang="en-ID" dirty="0"/>
              <a:t>, basophil, basophil </a:t>
            </a:r>
            <a:r>
              <a:rPr lang="en-ID" dirty="0" err="1"/>
              <a:t>absolut</a:t>
            </a:r>
            <a:r>
              <a:rPr lang="en-ID" dirty="0"/>
              <a:t>, IPF for healthy babies aged 3 months</a:t>
            </a:r>
          </a:p>
        </p:txBody>
      </p:sp>
    </p:spTree>
    <p:extLst>
      <p:ext uri="{BB962C8B-B14F-4D97-AF65-F5344CB8AC3E}">
        <p14:creationId xmlns:p14="http://schemas.microsoft.com/office/powerpoint/2010/main" val="35860492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17A23D6-19BD-4D0E-A6ED-4190858D39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8191" y="584257"/>
            <a:ext cx="8112154" cy="561783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A0BF889-E998-DACB-4CA3-349BD4255A5B}"/>
              </a:ext>
            </a:extLst>
          </p:cNvPr>
          <p:cNvSpPr txBox="1"/>
          <p:nvPr/>
        </p:nvSpPr>
        <p:spPr>
          <a:xfrm>
            <a:off x="3674378" y="1585519"/>
            <a:ext cx="603168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6d. Reference range of reticulocyte </a:t>
            </a:r>
            <a:r>
              <a:rPr lang="en-ID" dirty="0" err="1"/>
              <a:t>hemoglobin</a:t>
            </a:r>
            <a:r>
              <a:rPr lang="en-ID" dirty="0"/>
              <a:t>, reticulocyte </a:t>
            </a:r>
            <a:r>
              <a:rPr lang="en-ID" dirty="0" err="1"/>
              <a:t>hemoglobin</a:t>
            </a:r>
            <a:r>
              <a:rPr lang="en-ID" dirty="0"/>
              <a:t> %, reticulocyte </a:t>
            </a:r>
            <a:r>
              <a:rPr lang="en-ID" dirty="0" err="1"/>
              <a:t>hemoglobin</a:t>
            </a:r>
            <a:r>
              <a:rPr lang="en-ID" dirty="0"/>
              <a:t> in million, RPI, IRF, IG for healthy babies aged 3 months</a:t>
            </a:r>
          </a:p>
        </p:txBody>
      </p:sp>
    </p:spTree>
    <p:extLst>
      <p:ext uri="{BB962C8B-B14F-4D97-AF65-F5344CB8AC3E}">
        <p14:creationId xmlns:p14="http://schemas.microsoft.com/office/powerpoint/2010/main" val="3711838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08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lindungan ringoringo</dc:creator>
  <cp:lastModifiedBy>parlindungan ringoringo</cp:lastModifiedBy>
  <cp:revision>2</cp:revision>
  <dcterms:created xsi:type="dcterms:W3CDTF">2022-02-16T21:56:49Z</dcterms:created>
  <dcterms:modified xsi:type="dcterms:W3CDTF">2022-07-23T22:54:31Z</dcterms:modified>
</cp:coreProperties>
</file>